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668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-294" y="8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2602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933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0773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5230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8612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5119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5331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4518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5639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5011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41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0BFAE-5F89-430F-BCA0-E0E7443C612C}" type="datetimeFigureOut">
              <a:rPr lang="de-DE" smtClean="0"/>
              <a:t>30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A604E-34C5-4A48-9FBC-7E906A575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9510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647699" y="697548"/>
            <a:ext cx="10315837" cy="5561205"/>
            <a:chOff x="-101698" y="0"/>
            <a:chExt cx="7121126" cy="3740979"/>
          </a:xfrm>
        </p:grpSpPr>
        <p:grpSp>
          <p:nvGrpSpPr>
            <p:cNvPr id="3" name="Gruppieren 2"/>
            <p:cNvGrpSpPr/>
            <p:nvPr/>
          </p:nvGrpSpPr>
          <p:grpSpPr>
            <a:xfrm>
              <a:off x="-101698" y="0"/>
              <a:ext cx="7121126" cy="3093477"/>
              <a:chOff x="-101698" y="0"/>
              <a:chExt cx="7121126" cy="3093477"/>
            </a:xfrm>
          </p:grpSpPr>
          <p:sp>
            <p:nvSpPr>
              <p:cNvPr id="5" name="AutoForm 2"/>
              <p:cNvSpPr>
                <a:spLocks noChangeArrowheads="1"/>
              </p:cNvSpPr>
              <p:nvPr/>
            </p:nvSpPr>
            <p:spPr bwMode="auto">
              <a:xfrm rot="5400000">
                <a:off x="260605" y="1674802"/>
                <a:ext cx="853721" cy="1578324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US" sz="1600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Backward translation: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US" sz="1200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native speaker &amp;</a:t>
                </a:r>
                <a:endParaRPr lang="de-DE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US" sz="1200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employee of translation agency</a:t>
                </a:r>
                <a:endParaRPr lang="de-DE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" name="Gruppieren 5"/>
              <p:cNvGrpSpPr/>
              <p:nvPr/>
            </p:nvGrpSpPr>
            <p:grpSpPr>
              <a:xfrm>
                <a:off x="-101698" y="0"/>
                <a:ext cx="7121126" cy="3093477"/>
                <a:chOff x="-133529" y="0"/>
                <a:chExt cx="7121126" cy="3093477"/>
              </a:xfrm>
            </p:grpSpPr>
            <p:sp>
              <p:nvSpPr>
                <p:cNvPr id="7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400933" y="-534462"/>
                  <a:ext cx="542092" cy="1611016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2700">
                  <a:solidFill>
                    <a:srgbClr val="00B0F0"/>
                  </a:solidFill>
                </a:ln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Persian GDMQ-36</a:t>
                  </a:r>
                  <a:endParaRPr lang="de-DE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420050" y="422318"/>
                  <a:ext cx="502285" cy="1609442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Forward translation: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200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 native speakers</a:t>
                  </a:r>
                  <a:endParaRPr lang="de-DE" sz="12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5619504" y="110089"/>
                  <a:ext cx="657378" cy="2078808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2700">
                  <a:solidFill>
                    <a:srgbClr val="00B0F0"/>
                  </a:solidFill>
                </a:ln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Preliminary German version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of GDMQ-36</a:t>
                  </a:r>
                  <a:endParaRPr lang="de-DE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583910" y="8832"/>
                  <a:ext cx="1223010" cy="2196713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400"/>
                    </a:spcAft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Review no. 1: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171450" indent="-171450">
                    <a:lnSpc>
                      <a:spcPct val="107000"/>
                    </a:lnSpc>
                    <a:spcAft>
                      <a:spcPts val="20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1400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discussion of differences between two German versions of translation</a:t>
                  </a:r>
                  <a:endParaRPr lang="de-DE" sz="14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171450" indent="-171450">
                    <a:lnSpc>
                      <a:spcPct val="107000"/>
                    </a:lnSpc>
                    <a:spcAft>
                      <a:spcPts val="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1400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im: agreement on one German version</a:t>
                  </a:r>
                  <a:endParaRPr lang="de-DE" sz="14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563323" y="1368011"/>
                  <a:ext cx="1253490" cy="2197441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400"/>
                    </a:spcAft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Review no. 2: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171450" indent="-171450">
                    <a:lnSpc>
                      <a:spcPct val="107000"/>
                    </a:lnSpc>
                    <a:spcAft>
                      <a:spcPts val="20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1400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omparison of backward translated versions of Persian questionnaire with original GDMQ-36</a:t>
                  </a:r>
                  <a:endParaRPr lang="de-DE" sz="14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171450" indent="-171450">
                    <a:lnSpc>
                      <a:spcPct val="107000"/>
                    </a:lnSpc>
                    <a:spcAft>
                      <a:spcPts val="80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1400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im: elimination of inaccuracies in translation of German version</a:t>
                  </a:r>
                  <a:endParaRPr lang="de-DE" sz="14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2" name="Gerader Verbinder 11"/>
                <p:cNvCxnSpPr/>
                <p:nvPr/>
              </p:nvCxnSpPr>
              <p:spPr>
                <a:xfrm>
                  <a:off x="1551489" y="2457298"/>
                  <a:ext cx="382270" cy="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Gerader Verbinder 12"/>
                <p:cNvCxnSpPr/>
                <p:nvPr/>
              </p:nvCxnSpPr>
              <p:spPr>
                <a:xfrm flipH="1">
                  <a:off x="732339" y="620458"/>
                  <a:ext cx="0" cy="25146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Gerader Verbinder 13"/>
                <p:cNvCxnSpPr>
                  <a:cxnSpLocks/>
                </p:cNvCxnSpPr>
                <p:nvPr/>
              </p:nvCxnSpPr>
              <p:spPr>
                <a:xfrm flipV="1">
                  <a:off x="5941271" y="1683321"/>
                  <a:ext cx="0" cy="30821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Gerader Verbinder 14"/>
                <p:cNvCxnSpPr/>
                <p:nvPr/>
              </p:nvCxnSpPr>
              <p:spPr>
                <a:xfrm>
                  <a:off x="1551489" y="1149493"/>
                  <a:ext cx="382270" cy="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Gerader Verbinder 15"/>
                <p:cNvCxnSpPr/>
                <p:nvPr/>
              </p:nvCxnSpPr>
              <p:spPr>
                <a:xfrm>
                  <a:off x="4411145" y="2437132"/>
                  <a:ext cx="401007" cy="7711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5702130" y="1446599"/>
                  <a:ext cx="492125" cy="1842750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daptation of Preliminary German version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8" name="Gerader Verbinder 17"/>
                <p:cNvCxnSpPr/>
                <p:nvPr/>
              </p:nvCxnSpPr>
              <p:spPr>
                <a:xfrm>
                  <a:off x="4411145" y="1149493"/>
                  <a:ext cx="382270" cy="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" name="Textfeld 1"/>
            <p:cNvSpPr txBox="1"/>
            <p:nvPr/>
          </p:nvSpPr>
          <p:spPr>
            <a:xfrm>
              <a:off x="40889" y="3482534"/>
              <a:ext cx="4135679" cy="258445"/>
            </a:xfrm>
            <a:prstGeom prst="rect">
              <a:avLst/>
            </a:prstGeom>
            <a:solidFill>
              <a:prstClr val="white"/>
            </a:solidFill>
            <a:ln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1000"/>
                </a:spcAft>
              </a:pPr>
              <a:r>
                <a:rPr lang="en-US" sz="1200" b="1" kern="100" dirty="0">
                  <a:ea typeface="Calibri" panose="020F0502020204030204" pitchFamily="34" charset="0"/>
                  <a:cs typeface="Times New Roman" panose="02020603050405020304" pitchFamily="18" charset="0"/>
                </a:rPr>
                <a:t>Supplementary </a:t>
              </a:r>
              <a:r>
                <a:rPr lang="en-US" sz="1200" b="1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Figure 1.</a:t>
              </a:r>
              <a:r>
                <a:rPr lang="en-US" sz="1200" b="1" kern="100" dirty="0"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Flow </a:t>
              </a:r>
              <a:r>
                <a:rPr lang="en-US" sz="1200" kern="100" dirty="0"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hart showing the translation process of the Persian GDMQ-36</a:t>
              </a:r>
              <a:endParaRPr lang="de-DE" sz="12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95579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188720" y="264160"/>
            <a:ext cx="9215120" cy="6253197"/>
            <a:chOff x="668838" y="94049"/>
            <a:chExt cx="3920944" cy="3274977"/>
          </a:xfrm>
        </p:grpSpPr>
        <p:grpSp>
          <p:nvGrpSpPr>
            <p:cNvPr id="3" name="Gruppieren 2"/>
            <p:cNvGrpSpPr/>
            <p:nvPr/>
          </p:nvGrpSpPr>
          <p:grpSpPr>
            <a:xfrm>
              <a:off x="668838" y="94049"/>
              <a:ext cx="3920944" cy="3274977"/>
              <a:chOff x="668884" y="94059"/>
              <a:chExt cx="3921222" cy="3275303"/>
            </a:xfrm>
          </p:grpSpPr>
          <p:sp>
            <p:nvSpPr>
              <p:cNvPr id="5" name="AutoForm 2"/>
              <p:cNvSpPr>
                <a:spLocks noChangeArrowheads="1"/>
              </p:cNvSpPr>
              <p:nvPr/>
            </p:nvSpPr>
            <p:spPr bwMode="auto">
              <a:xfrm rot="5400000">
                <a:off x="1751913" y="671744"/>
                <a:ext cx="616518" cy="932469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600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Adjustments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22 questions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AutoForm 2"/>
              <p:cNvSpPr>
                <a:spLocks noChangeArrowheads="1"/>
              </p:cNvSpPr>
              <p:nvPr/>
            </p:nvSpPr>
            <p:spPr bwMode="auto">
              <a:xfrm rot="5400000">
                <a:off x="3867793" y="724906"/>
                <a:ext cx="614045" cy="830580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600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Deletion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2 questions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" name="Gerader Verbinder 6"/>
              <p:cNvCxnSpPr>
                <a:cxnSpLocks/>
              </p:cNvCxnSpPr>
              <p:nvPr/>
            </p:nvCxnSpPr>
            <p:spPr>
              <a:xfrm>
                <a:off x="3439063" y="512798"/>
                <a:ext cx="253833" cy="140471"/>
              </a:xfrm>
              <a:prstGeom prst="line">
                <a:avLst/>
              </a:prstGeom>
              <a:solidFill>
                <a:srgbClr val="000000">
                  <a:alpha val="5000"/>
                </a:srgbClr>
              </a:solidFill>
              <a:ln w="9000">
                <a:solidFill>
                  <a:srgbClr val="0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Gerader Verbinder 7"/>
              <p:cNvCxnSpPr>
                <a:cxnSpLocks/>
              </p:cNvCxnSpPr>
              <p:nvPr/>
            </p:nvCxnSpPr>
            <p:spPr>
              <a:xfrm flipH="1">
                <a:off x="1485376" y="512797"/>
                <a:ext cx="249798" cy="141424"/>
              </a:xfrm>
              <a:prstGeom prst="line">
                <a:avLst/>
              </a:prstGeom>
              <a:solidFill>
                <a:srgbClr val="000000">
                  <a:alpha val="5000"/>
                </a:srgbClr>
              </a:solidFill>
              <a:ln w="9000">
                <a:solidFill>
                  <a:srgbClr val="0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AutoForm 2"/>
              <p:cNvSpPr>
                <a:spLocks noChangeArrowheads="1"/>
              </p:cNvSpPr>
              <p:nvPr/>
            </p:nvSpPr>
            <p:spPr bwMode="auto">
              <a:xfrm rot="5400000">
                <a:off x="753723" y="736809"/>
                <a:ext cx="647160" cy="816837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600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Left idem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8 questions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AutoForm 2"/>
              <p:cNvSpPr>
                <a:spLocks noChangeArrowheads="1"/>
              </p:cNvSpPr>
              <p:nvPr/>
            </p:nvSpPr>
            <p:spPr bwMode="auto">
              <a:xfrm rot="5400000">
                <a:off x="2857382" y="682059"/>
                <a:ext cx="594995" cy="909955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600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Fusion (2in1)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2x 2 questions</a:t>
                </a:r>
                <a:endParaRPr lang="de-DE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" name="Gerader Verbinder 10"/>
              <p:cNvCxnSpPr>
                <a:cxnSpLocks/>
              </p:cNvCxnSpPr>
              <p:nvPr/>
            </p:nvCxnSpPr>
            <p:spPr>
              <a:xfrm>
                <a:off x="2866777" y="565739"/>
                <a:ext cx="104986" cy="144052"/>
              </a:xfrm>
              <a:prstGeom prst="line">
                <a:avLst/>
              </a:prstGeom>
              <a:solidFill>
                <a:srgbClr val="000000">
                  <a:alpha val="5000"/>
                </a:srgbClr>
              </a:solidFill>
              <a:ln w="9000">
                <a:solidFill>
                  <a:srgbClr val="0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r Verbinder 11"/>
              <p:cNvCxnSpPr>
                <a:cxnSpLocks/>
              </p:cNvCxnSpPr>
              <p:nvPr/>
            </p:nvCxnSpPr>
            <p:spPr>
              <a:xfrm flipH="1">
                <a:off x="2139615" y="558470"/>
                <a:ext cx="97488" cy="139870"/>
              </a:xfrm>
              <a:prstGeom prst="line">
                <a:avLst/>
              </a:prstGeom>
              <a:solidFill>
                <a:srgbClr val="000000">
                  <a:alpha val="5000"/>
                </a:srgbClr>
              </a:solidFill>
              <a:ln w="9000">
                <a:solidFill>
                  <a:srgbClr val="0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Gerader Verbinder 12"/>
              <p:cNvCxnSpPr/>
              <p:nvPr/>
            </p:nvCxnSpPr>
            <p:spPr>
              <a:xfrm>
                <a:off x="2597863" y="1434534"/>
                <a:ext cx="0" cy="216329"/>
              </a:xfrm>
              <a:prstGeom prst="line">
                <a:avLst/>
              </a:prstGeom>
              <a:solidFill>
                <a:srgbClr val="000000">
                  <a:alpha val="5000"/>
                </a:srgbClr>
              </a:solidFill>
              <a:ln w="9000">
                <a:solidFill>
                  <a:srgbClr val="0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AutoForm 2"/>
              <p:cNvSpPr>
                <a:spLocks noChangeArrowheads="1"/>
              </p:cNvSpPr>
              <p:nvPr/>
            </p:nvSpPr>
            <p:spPr bwMode="auto">
              <a:xfrm rot="5400000">
                <a:off x="2466989" y="2278142"/>
                <a:ext cx="322035" cy="1286914"/>
              </a:xfrm>
              <a:prstGeom prst="roundRect">
                <a:avLst>
                  <a:gd name="adj" fmla="val 13032"/>
                </a:avLst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rgbClr val="00B0F0"/>
                </a:solidFill>
              </a:ln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  <a:sym typeface="Wingdings" panose="05000000000000000000" pitchFamily="2" charset="2"/>
                  </a:rPr>
                  <a:t></a:t>
                </a:r>
                <a:r>
                  <a:rPr lang="en-US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   In total: 53 questions</a:t>
                </a:r>
                <a:r>
                  <a:rPr lang="en-US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  <a:endParaRPr lang="de-DE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AutoForm 2"/>
              <p:cNvSpPr>
                <a:spLocks noChangeArrowheads="1"/>
              </p:cNvSpPr>
              <p:nvPr/>
            </p:nvSpPr>
            <p:spPr bwMode="auto">
              <a:xfrm rot="5400000">
                <a:off x="2437072" y="-387146"/>
                <a:ext cx="344213" cy="1306623"/>
              </a:xfrm>
              <a:prstGeom prst="roundRect">
                <a:avLst>
                  <a:gd name="adj" fmla="val 13032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36 questions</a:t>
                </a:r>
                <a:r>
                  <a:rPr lang="en-US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  <a:endParaRPr lang="de-DE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feld 1"/>
              <p:cNvSpPr txBox="1"/>
              <p:nvPr/>
            </p:nvSpPr>
            <p:spPr>
              <a:xfrm>
                <a:off x="668884" y="3227938"/>
                <a:ext cx="1857523" cy="141424"/>
              </a:xfrm>
              <a:prstGeom prst="rect">
                <a:avLst/>
              </a:prstGeom>
              <a:solidFill>
                <a:prstClr val="white"/>
              </a:solidFill>
              <a:ln>
                <a:noFill/>
              </a:ln>
            </p:spPr>
            <p:txBody>
              <a:bodyPr rot="0" spcFirstLastPara="0" vert="horz" wrap="square" lIns="36000" tIns="36000" rIns="36000" bIns="36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1000"/>
                  </a:spcAft>
                </a:pPr>
                <a:r>
                  <a:rPr lang="en-US" sz="1200" b="1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Figure 2. </a:t>
                </a:r>
                <a:r>
                  <a:rPr lang="en-US" sz="12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Flow chart of the cognitive </a:t>
                </a:r>
                <a:r>
                  <a:rPr lang="en-US" sz="1200" kern="100" dirty="0">
                    <a:ea typeface="Calibri" panose="020F0502020204030204" pitchFamily="34" charset="0"/>
                    <a:cs typeface="Times New Roman" panose="02020603050405020304" pitchFamily="18" charset="0"/>
                  </a:rPr>
                  <a:t>d</a:t>
                </a:r>
                <a:r>
                  <a:rPr lang="en-US" sz="12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ebriefing I </a:t>
                </a:r>
                <a:endParaRPr lang="de-DE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AutoForm 2"/>
            <p:cNvSpPr>
              <a:spLocks noChangeArrowheads="1"/>
            </p:cNvSpPr>
            <p:nvPr/>
          </p:nvSpPr>
          <p:spPr bwMode="auto">
            <a:xfrm rot="5400000">
              <a:off x="2263829" y="1415617"/>
              <a:ext cx="766011" cy="1324848"/>
            </a:xfrm>
            <a:prstGeom prst="roundRect">
              <a:avLst>
                <a:gd name="adj" fmla="val 13032"/>
              </a:avLst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rot="0" vert="horz" wrap="square" lIns="108000" tIns="108000" rIns="108000" bIns="108000" anchor="ctr" anchorCtr="0" upright="1">
              <a:noAutofit/>
            </a:bodyPr>
            <a:lstStyle/>
            <a:p>
              <a:pPr algn="ctr">
                <a:lnSpc>
                  <a:spcPct val="107000"/>
                </a:lnSpc>
              </a:pPr>
              <a:r>
                <a:rPr lang="en-US" sz="1600" b="1" kern="100" dirty="0">
                  <a:solidFill>
                    <a:srgbClr val="4472C4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+ 21 questions</a:t>
              </a:r>
              <a:endParaRPr lang="de-DE" sz="16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107000"/>
                </a:lnSpc>
              </a:pPr>
              <a:r>
                <a:rPr lang="en-US" sz="14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via recommendations of the women</a:t>
              </a:r>
            </a:p>
            <a:p>
              <a:pPr algn="ctr">
                <a:lnSpc>
                  <a:spcPct val="107000"/>
                </a:lnSpc>
              </a:pPr>
              <a:r>
                <a:rPr lang="en-US" sz="14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suffering from GDM</a:t>
              </a:r>
              <a:endParaRPr lang="de-DE" sz="14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3322DC4C-44C5-87C1-A6BE-C765EAAFC700}"/>
              </a:ext>
            </a:extLst>
          </p:cNvPr>
          <p:cNvCxnSpPr/>
          <p:nvPr/>
        </p:nvCxnSpPr>
        <p:spPr>
          <a:xfrm>
            <a:off x="5787680" y="4825216"/>
            <a:ext cx="0" cy="413015"/>
          </a:xfrm>
          <a:prstGeom prst="line">
            <a:avLst/>
          </a:prstGeom>
          <a:solidFill>
            <a:srgbClr val="000000">
              <a:alpha val="5000"/>
            </a:srgbClr>
          </a:solidFill>
          <a:ln w="9000">
            <a:solidFill>
              <a:srgbClr val="0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078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873759" y="82994"/>
            <a:ext cx="10365726" cy="6775005"/>
            <a:chOff x="-1" y="-251222"/>
            <a:chExt cx="6005549" cy="6606290"/>
          </a:xfrm>
        </p:grpSpPr>
        <p:sp>
          <p:nvSpPr>
            <p:cNvPr id="3" name="AutoForm 2"/>
            <p:cNvSpPr>
              <a:spLocks noChangeArrowheads="1"/>
            </p:cNvSpPr>
            <p:nvPr/>
          </p:nvSpPr>
          <p:spPr bwMode="auto">
            <a:xfrm rot="5400000">
              <a:off x="2668877" y="4955931"/>
              <a:ext cx="471523" cy="1661988"/>
            </a:xfrm>
            <a:prstGeom prst="roundRect">
              <a:avLst>
                <a:gd name="adj" fmla="val 13032"/>
              </a:avLst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rgbClr val="00B0F0"/>
              </a:solidFill>
            </a:ln>
          </p:spPr>
          <p:txBody>
            <a:bodyPr rot="0" vert="horz" wrap="square" lIns="108000" tIns="108000" rIns="108000" bIns="108000" anchor="ctr" anchorCtr="0" upright="1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ea typeface="Calibri" panose="020F0502020204030204" pitchFamily="34" charset="0"/>
                  <a:cs typeface="Times New Roman" panose="02020603050405020304" pitchFamily="18" charset="0"/>
                  <a:sym typeface="Wingdings" panose="05000000000000000000" pitchFamily="2" charset="2"/>
                </a:rPr>
                <a:t></a:t>
              </a:r>
              <a:r>
                <a:rPr kumimoji="0" lang="en-US" b="1" i="0" u="none" strike="noStrike" kern="1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ea typeface="Calibri" panose="020F0502020204030204" pitchFamily="34" charset="0"/>
                  <a:cs typeface="Times New Roman" panose="02020603050405020304" pitchFamily="18" charset="0"/>
                </a:rPr>
                <a:t>   In total: 49 questions</a:t>
              </a:r>
              <a:endParaRPr kumimoji="0" lang="de-DE" b="0" i="0" u="none" strike="noStrike" kern="1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-1" y="-251222"/>
              <a:ext cx="6005549" cy="6606290"/>
              <a:chOff x="-1" y="-251236"/>
              <a:chExt cx="6005574" cy="6606678"/>
            </a:xfrm>
          </p:grpSpPr>
          <p:grpSp>
            <p:nvGrpSpPr>
              <p:cNvPr id="5" name="Gruppieren 4"/>
              <p:cNvGrpSpPr/>
              <p:nvPr/>
            </p:nvGrpSpPr>
            <p:grpSpPr>
              <a:xfrm>
                <a:off x="0" y="-251236"/>
                <a:ext cx="6005573" cy="5740082"/>
                <a:chOff x="0" y="-251236"/>
                <a:chExt cx="6005573" cy="5740082"/>
              </a:xfrm>
            </p:grpSpPr>
            <p:cxnSp>
              <p:nvCxnSpPr>
                <p:cNvPr id="7" name="Gerader Verbinder 6"/>
                <p:cNvCxnSpPr>
                  <a:cxnSpLocks/>
                </p:cNvCxnSpPr>
                <p:nvPr/>
              </p:nvCxnSpPr>
              <p:spPr>
                <a:xfrm flipH="1">
                  <a:off x="1953797" y="829528"/>
                  <a:ext cx="229555" cy="166798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8" name="Gerader Verbinder 7"/>
                <p:cNvCxnSpPr>
                  <a:cxnSpLocks/>
                </p:cNvCxnSpPr>
                <p:nvPr/>
              </p:nvCxnSpPr>
              <p:spPr>
                <a:xfrm>
                  <a:off x="3526150" y="798549"/>
                  <a:ext cx="204476" cy="195411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9" name="Gerader Verbinder 8"/>
                <p:cNvCxnSpPr>
                  <a:cxnSpLocks/>
                </p:cNvCxnSpPr>
                <p:nvPr/>
              </p:nvCxnSpPr>
              <p:spPr>
                <a:xfrm rot="5400000">
                  <a:off x="2655528" y="403796"/>
                  <a:ext cx="185420" cy="635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10" name="Textfeld 2"/>
                <p:cNvSpPr txBox="1">
                  <a:spLocks noChangeArrowheads="1"/>
                </p:cNvSpPr>
                <p:nvPr/>
              </p:nvSpPr>
              <p:spPr bwMode="auto">
                <a:xfrm>
                  <a:off x="1098455" y="885291"/>
                  <a:ext cx="583750" cy="311279"/>
                </a:xfrm>
                <a:prstGeom prst="rect">
                  <a:avLst/>
                </a:prstGeom>
                <a:noFill/>
                <a:ln w="9525">
                  <a:solidFill>
                    <a:sysClr val="window" lastClr="FFFFFF"/>
                  </a:solidFill>
                  <a:miter lim="800000"/>
                  <a:headEnd/>
                  <a:tailEnd/>
                </a:ln>
                <a:effectLst/>
              </p:spPr>
              <p:txBody>
                <a:bodyPr rot="0" vert="horz" wrap="square" lIns="0" tIns="0" rIns="0" bIns="0" anchor="t" anchorCtr="0">
                  <a:no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URWPalladioL-Roma"/>
                      <a:cs typeface="Arial" panose="020B0604020202020204" pitchFamily="34" charset="0"/>
                    </a:rPr>
                    <a:t>CVI &gt; 0.79</a:t>
                  </a:r>
                </a:p>
              </p:txBody>
            </p:sp>
            <p:sp>
              <p:nvSpPr>
                <p:cNvPr id="11" name="Textfeld 2"/>
                <p:cNvSpPr txBox="1">
                  <a:spLocks noChangeArrowheads="1"/>
                </p:cNvSpPr>
                <p:nvPr/>
              </p:nvSpPr>
              <p:spPr bwMode="auto">
                <a:xfrm>
                  <a:off x="3939130" y="871971"/>
                  <a:ext cx="577395" cy="248712"/>
                </a:xfrm>
                <a:prstGeom prst="rect">
                  <a:avLst/>
                </a:prstGeom>
                <a:noFill/>
                <a:ln w="9525">
                  <a:solidFill>
                    <a:sysClr val="window" lastClr="FFFFFF"/>
                  </a:solidFill>
                  <a:miter lim="800000"/>
                  <a:headEnd/>
                  <a:tailEnd/>
                </a:ln>
                <a:effectLst/>
              </p:spPr>
              <p:txBody>
                <a:bodyPr rot="0" vert="horz" wrap="square" lIns="0" tIns="0" rIns="0" bIns="0" anchor="t" anchorCtr="0">
                  <a:no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URWPalladioL-Roma"/>
                      <a:cs typeface="Arial" panose="020B0604020202020204" pitchFamily="34" charset="0"/>
                    </a:rPr>
                    <a:t>CVI &lt; 0.79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2" name="Gerader Verbinder 11"/>
                <p:cNvCxnSpPr>
                  <a:cxnSpLocks/>
                </p:cNvCxnSpPr>
                <p:nvPr/>
              </p:nvCxnSpPr>
              <p:spPr>
                <a:xfrm flipH="1">
                  <a:off x="2920261" y="3726827"/>
                  <a:ext cx="1" cy="324055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13" name="Textfeld 2"/>
                <p:cNvSpPr txBox="1">
                  <a:spLocks noChangeArrowheads="1"/>
                </p:cNvSpPr>
                <p:nvPr/>
              </p:nvSpPr>
              <p:spPr bwMode="auto">
                <a:xfrm>
                  <a:off x="304481" y="2122915"/>
                  <a:ext cx="1964513" cy="260350"/>
                </a:xfrm>
                <a:prstGeom prst="rect">
                  <a:avLst/>
                </a:prstGeom>
                <a:solidFill>
                  <a:sysClr val="window" lastClr="FFFFFF">
                    <a:tint val="95000"/>
                    <a:satMod val="170000"/>
                  </a:sysClr>
                </a:solidFill>
                <a:ln w="9525">
                  <a:solidFill>
                    <a:sysClr val="window" lastClr="FFFFFF"/>
                  </a:solidFill>
                  <a:miter lim="800000"/>
                  <a:headEnd/>
                  <a:tailEnd/>
                </a:ln>
                <a:effectLst/>
              </p:spPr>
              <p:txBody>
                <a:bodyPr rot="0" vert="horz" wrap="square" lIns="0" tIns="0" rIns="0" bIns="0" anchor="t" anchorCtr="0">
                  <a:noAutofit/>
                </a:bodyPr>
                <a:lstStyle/>
                <a:p>
                  <a:pPr marL="44958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No adaptations required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053552" y="991251"/>
                  <a:ext cx="673556" cy="92773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Relevant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9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3891051" y="969965"/>
                  <a:ext cx="673555" cy="95313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Not relevant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4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6" name="Gerader Verbinder 15"/>
                <p:cNvCxnSpPr/>
                <p:nvPr/>
              </p:nvCxnSpPr>
              <p:spPr>
                <a:xfrm rot="5400000" flipV="1">
                  <a:off x="1295081" y="1966554"/>
                  <a:ext cx="180725" cy="2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17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849792" y="2004088"/>
                  <a:ext cx="836467" cy="932181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djustment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8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3833882" y="2058223"/>
                  <a:ext cx="829167" cy="83121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Deletion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1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9" name="Gerader Verbinder 18"/>
                <p:cNvCxnSpPr/>
                <p:nvPr/>
              </p:nvCxnSpPr>
              <p:spPr>
                <a:xfrm rot="1577623">
                  <a:off x="4752656" y="1857634"/>
                  <a:ext cx="213361" cy="1016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20" name="Gerader Verbinder 19"/>
                <p:cNvCxnSpPr/>
                <p:nvPr/>
              </p:nvCxnSpPr>
              <p:spPr>
                <a:xfrm rot="9386807" flipV="1">
                  <a:off x="3523931" y="1872251"/>
                  <a:ext cx="208915" cy="5461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21" name="Gerader Verbinder 20"/>
                <p:cNvCxnSpPr/>
                <p:nvPr/>
              </p:nvCxnSpPr>
              <p:spPr>
                <a:xfrm rot="5400000">
                  <a:off x="4123689" y="1895416"/>
                  <a:ext cx="182245" cy="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22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4971776" y="1844895"/>
                  <a:ext cx="829169" cy="123842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Left idem (CVI &gt; 0.65)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5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63298" y="2979585"/>
                  <a:ext cx="690013" cy="816610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Left idem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4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105624" y="2890519"/>
                  <a:ext cx="683984" cy="1028721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djustment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5" name="Gerader Verbinder 24"/>
                <p:cNvCxnSpPr>
                  <a:cxnSpLocks/>
                </p:cNvCxnSpPr>
                <p:nvPr/>
              </p:nvCxnSpPr>
              <p:spPr>
                <a:xfrm flipH="1">
                  <a:off x="702374" y="2526777"/>
                  <a:ext cx="148843" cy="201349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26" name="Gerader Verbinder 25"/>
                <p:cNvCxnSpPr>
                  <a:cxnSpLocks/>
                </p:cNvCxnSpPr>
                <p:nvPr/>
              </p:nvCxnSpPr>
              <p:spPr>
                <a:xfrm>
                  <a:off x="2060241" y="2484230"/>
                  <a:ext cx="153811" cy="225361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27" name="Gerader Verbinder 26"/>
                <p:cNvCxnSpPr/>
                <p:nvPr/>
              </p:nvCxnSpPr>
              <p:spPr>
                <a:xfrm rot="5400000" flipV="1">
                  <a:off x="1257616" y="2618850"/>
                  <a:ext cx="269240" cy="0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28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3407283" y="2911093"/>
                  <a:ext cx="714626" cy="107759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0.3 &gt; CVI &lt; 0,55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9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9" name="Gerader Verbinder 28"/>
                <p:cNvCxnSpPr>
                  <a:cxnSpLocks/>
                </p:cNvCxnSpPr>
                <p:nvPr/>
              </p:nvCxnSpPr>
              <p:spPr>
                <a:xfrm flipH="1">
                  <a:off x="4021816" y="2862468"/>
                  <a:ext cx="55121" cy="230109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30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4605753" y="2897280"/>
                  <a:ext cx="725425" cy="108521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VI =0.65; 0.75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 2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045325" y="2946884"/>
                  <a:ext cx="690012" cy="90995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Fusion (2in1)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 question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310711" y="3863249"/>
                  <a:ext cx="1219102" cy="1661995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+ 8 questions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via recommendations of medical professionals from expert rating</a:t>
                  </a:r>
                  <a:endParaRPr kumimoji="0" lang="de-DE" sz="14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3" name="Gerader Verbinder 32"/>
                <p:cNvCxnSpPr>
                  <a:cxnSpLocks/>
                </p:cNvCxnSpPr>
                <p:nvPr/>
              </p:nvCxnSpPr>
              <p:spPr>
                <a:xfrm>
                  <a:off x="4458358" y="2841537"/>
                  <a:ext cx="88690" cy="256172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cxnSp>
              <p:nvCxnSpPr>
                <p:cNvPr id="34" name="Gerader Verbinder 33"/>
                <p:cNvCxnSpPr/>
                <p:nvPr/>
              </p:nvCxnSpPr>
              <p:spPr>
                <a:xfrm>
                  <a:off x="2925127" y="5303798"/>
                  <a:ext cx="0" cy="185048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 cap="flat" cmpd="sng" algn="ctr">
                  <a:solidFill>
                    <a:srgbClr val="000000"/>
                  </a:solidFill>
                  <a:prstDash val="solid"/>
                  <a:miter lim="800000"/>
                  <a:tailEnd type="arrow"/>
                </a:ln>
                <a:effectLst/>
              </p:spPr>
            </p:cxnSp>
            <p:sp>
              <p:nvSpPr>
                <p:cNvPr id="35" name="Textfeld 2"/>
                <p:cNvSpPr txBox="1">
                  <a:spLocks noChangeArrowheads="1"/>
                </p:cNvSpPr>
                <p:nvPr/>
              </p:nvSpPr>
              <p:spPr bwMode="auto">
                <a:xfrm>
                  <a:off x="2164014" y="483056"/>
                  <a:ext cx="1259512" cy="646823"/>
                </a:xfrm>
                <a:prstGeom prst="rect">
                  <a:avLst/>
                </a:prstGeom>
                <a:solidFill>
                  <a:sysClr val="window" lastClr="FFFFFF">
                    <a:tint val="95000"/>
                    <a:satMod val="170000"/>
                  </a:sysClr>
                </a:solidFill>
                <a:ln w="9525">
                  <a:solidFill>
                    <a:sysClr val="window" lastClr="FFFFFF"/>
                  </a:solidFill>
                  <a:miter lim="800000"/>
                  <a:headEnd/>
                  <a:tailEnd/>
                </a:ln>
                <a:effectLst/>
              </p:spPr>
              <p:txBody>
                <a:bodyPr rot="0" vert="horz" wrap="square" lIns="108000" tIns="72000" rIns="72000" bIns="72000" anchor="t" anchorCtr="0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URWPalladioL-Roma"/>
                      <a:cs typeface="Arial" panose="020B0604020202020204" pitchFamily="34" charset="0"/>
                    </a:rPr>
                    <a:t>CVI according to Waltz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URWPalladioL-Roma"/>
                      <a:cs typeface="Arial" panose="020B0604020202020204" pitchFamily="34" charset="0"/>
                    </a:rPr>
                    <a:t>and Baussell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476011" y="-685447"/>
                  <a:ext cx="543817" cy="1412240"/>
                </a:xfrm>
                <a:prstGeom prst="roundRect">
                  <a:avLst>
                    <a:gd name="adj" fmla="val 13032"/>
                  </a:avLst>
                </a:prstGeom>
                <a:solidFill>
                  <a:srgbClr val="4472C4">
                    <a:lumMod val="20000"/>
                    <a:lumOff val="80000"/>
                  </a:srgb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600" b="1" i="0" u="none" strike="noStrike" kern="100" cap="none" spc="0" normalizeH="0" baseline="0" noProof="0" dirty="0">
                    <a:ln>
                      <a:noFill/>
                    </a:ln>
                    <a:solidFill>
                      <a:srgbClr val="4472C4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b="1" i="0" u="none" strike="noStrike" kern="100" cap="none" spc="0" normalizeH="0" baseline="0" noProof="0" dirty="0">
                      <a:ln>
                        <a:noFill/>
                      </a:ln>
                      <a:solidFill>
                        <a:srgbClr val="4472C4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53 questions</a:t>
                  </a:r>
                  <a:endParaRPr kumimoji="0" lang="de-DE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600" b="0" i="0" u="none" strike="noStrike" kern="1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 </a:t>
                  </a:r>
                  <a:endParaRPr kumimoji="0" lang="de-DE" sz="16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Textfeld 1"/>
              <p:cNvSpPr txBox="1"/>
              <p:nvPr/>
            </p:nvSpPr>
            <p:spPr>
              <a:xfrm>
                <a:off x="-1" y="6023041"/>
                <a:ext cx="2041801" cy="332401"/>
              </a:xfrm>
              <a:prstGeom prst="rect">
                <a:avLst/>
              </a:prstGeom>
              <a:solidFill>
                <a:prstClr val="white"/>
              </a:solidFill>
              <a:ln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lvl="0">
                  <a:lnSpc>
                    <a:spcPct val="107000"/>
                  </a:lnSpc>
                  <a:spcAft>
                    <a:spcPts val="1000"/>
                  </a:spcAft>
                  <a:defRPr/>
                </a:pPr>
                <a:r>
                  <a:rPr kumimoji="0" lang="en-US" sz="1200" b="1" u="none" strike="noStrike" kern="1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Figure 3.</a:t>
                </a:r>
                <a:r>
                  <a:rPr kumimoji="0" lang="en-US" sz="1200" b="0" u="none" strike="noStrike" kern="1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ea typeface="Calibri" panose="020F0502020204030204" pitchFamily="34" charset="0"/>
                    <a:cs typeface="Times New Roman" panose="02020603050405020304" pitchFamily="18" charset="0"/>
                  </a:rPr>
                  <a:t> Flow </a:t>
                </a:r>
                <a:r>
                  <a:rPr lang="en-US" sz="1200" kern="100" dirty="0">
                    <a:ea typeface="Calibri" panose="020F0502020204030204" pitchFamily="34" charset="0"/>
                    <a:cs typeface="Times New Roman" panose="02020603050405020304" pitchFamily="18" charset="0"/>
                  </a:rPr>
                  <a:t>chart of the expert rating</a:t>
                </a:r>
                <a:endParaRPr kumimoji="0" lang="de-DE" sz="1200" b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026106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356758" y="520175"/>
            <a:ext cx="8346041" cy="5649655"/>
            <a:chOff x="94891" y="-2820"/>
            <a:chExt cx="4093846" cy="3349407"/>
          </a:xfrm>
        </p:grpSpPr>
        <p:sp>
          <p:nvSpPr>
            <p:cNvPr id="3" name="Textfeld 1"/>
            <p:cNvSpPr txBox="1"/>
            <p:nvPr/>
          </p:nvSpPr>
          <p:spPr>
            <a:xfrm>
              <a:off x="94891" y="3088096"/>
              <a:ext cx="2231219" cy="258491"/>
            </a:xfrm>
            <a:prstGeom prst="rect">
              <a:avLst/>
            </a:prstGeom>
            <a:solidFill>
              <a:prstClr val="white"/>
            </a:solidFill>
            <a:ln>
              <a:noFill/>
            </a:ln>
          </p:spPr>
          <p:txBody>
            <a:bodyPr rot="0" spcFirstLastPara="0" vert="horz" wrap="square" lIns="108000" tIns="108000" rIns="108000" bIns="10800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1000"/>
                </a:spcAft>
              </a:pPr>
              <a:r>
                <a:rPr lang="en-US" sz="1200" b="1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4. </a:t>
              </a:r>
              <a:r>
                <a:rPr lang="en-US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Flow</a:t>
              </a:r>
              <a:r>
                <a:rPr lang="en-US" sz="1200" kern="100" dirty="0">
                  <a:ea typeface="Calibri" panose="020F0502020204030204" pitchFamily="34" charset="0"/>
                  <a:cs typeface="Times New Roman" panose="02020603050405020304" pitchFamily="18" charset="0"/>
                </a:rPr>
                <a:t> c</a:t>
              </a:r>
              <a:r>
                <a:rPr lang="en-US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hart of the cognitive debriefing II</a:t>
              </a:r>
              <a:endParaRPr lang="de-DE" sz="12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94891" y="-2820"/>
              <a:ext cx="4093846" cy="3033509"/>
              <a:chOff x="0" y="-2820"/>
              <a:chExt cx="4094238" cy="3033802"/>
            </a:xfrm>
          </p:grpSpPr>
          <p:grpSp>
            <p:nvGrpSpPr>
              <p:cNvPr id="5" name="Gruppieren 4"/>
              <p:cNvGrpSpPr/>
              <p:nvPr/>
            </p:nvGrpSpPr>
            <p:grpSpPr>
              <a:xfrm>
                <a:off x="0" y="-2820"/>
                <a:ext cx="4094238" cy="2603010"/>
                <a:chOff x="0" y="-2820"/>
                <a:chExt cx="4094238" cy="2603010"/>
              </a:xfrm>
            </p:grpSpPr>
            <p:sp>
              <p:nvSpPr>
                <p:cNvPr id="7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896339" y="-521220"/>
                  <a:ext cx="374400" cy="1411200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9 questions questions</a:t>
                  </a:r>
                  <a:endParaRPr lang="de-DE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236579" y="613306"/>
                  <a:ext cx="616555" cy="932496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djustment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</a:pPr>
                  <a:r>
                    <a:rPr lang="en-US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5 question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3373671" y="643021"/>
                  <a:ext cx="609919" cy="831215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Deletion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</a:pPr>
                  <a:r>
                    <a:rPr lang="en-US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 question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0" name="Gerader Verbinder 9"/>
                <p:cNvCxnSpPr>
                  <a:cxnSpLocks/>
                </p:cNvCxnSpPr>
                <p:nvPr/>
              </p:nvCxnSpPr>
              <p:spPr>
                <a:xfrm>
                  <a:off x="2957295" y="443203"/>
                  <a:ext cx="163731" cy="153422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Gerader Verbinder 10"/>
                <p:cNvCxnSpPr>
                  <a:cxnSpLocks/>
                </p:cNvCxnSpPr>
                <p:nvPr/>
              </p:nvCxnSpPr>
              <p:spPr>
                <a:xfrm flipH="1">
                  <a:off x="1029972" y="479169"/>
                  <a:ext cx="231037" cy="144823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72001" y="608349"/>
                  <a:ext cx="611188" cy="955190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Left idem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</a:pPr>
                  <a:r>
                    <a:rPr lang="en-US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8 question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2341161" y="610635"/>
                  <a:ext cx="594995" cy="909955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Split (1 into 2)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</a:pPr>
                  <a:r>
                    <a:rPr lang="en-US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 x 1 question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" name="Gerader Verbinder 13"/>
                <p:cNvCxnSpPr>
                  <a:cxnSpLocks/>
                </p:cNvCxnSpPr>
                <p:nvPr/>
              </p:nvCxnSpPr>
              <p:spPr>
                <a:xfrm>
                  <a:off x="2322216" y="484030"/>
                  <a:ext cx="190516" cy="158662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Gerader Verbinder 14"/>
                <p:cNvCxnSpPr>
                  <a:cxnSpLocks/>
                </p:cNvCxnSpPr>
                <p:nvPr/>
              </p:nvCxnSpPr>
              <p:spPr>
                <a:xfrm flipH="1">
                  <a:off x="1620064" y="490464"/>
                  <a:ext cx="170811" cy="151122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Gerader Verbinder 15"/>
                <p:cNvCxnSpPr>
                  <a:cxnSpLocks/>
                </p:cNvCxnSpPr>
                <p:nvPr/>
              </p:nvCxnSpPr>
              <p:spPr>
                <a:xfrm>
                  <a:off x="2083539" y="1363110"/>
                  <a:ext cx="0" cy="192827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722354" y="1066802"/>
                  <a:ext cx="746760" cy="1839595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5">
                    <a:lumMod val="20000"/>
                    <a:lumOff val="80000"/>
                  </a:schemeClr>
                </a:solidFill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sz="1600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+ 8 questions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7000"/>
                    </a:lnSpc>
                  </a:pPr>
                  <a:r>
                    <a:rPr lang="en-US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via recommendations of the women suffering from GDM</a:t>
                  </a:r>
                  <a:endParaRPr lang="de-DE" sz="16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8" name="Gerader Verbinder 17"/>
                <p:cNvCxnSpPr>
                  <a:cxnSpLocks/>
                </p:cNvCxnSpPr>
                <p:nvPr/>
              </p:nvCxnSpPr>
              <p:spPr>
                <a:xfrm>
                  <a:off x="2095734" y="2418072"/>
                  <a:ext cx="0" cy="182118"/>
                </a:xfrm>
                <a:prstGeom prst="line">
                  <a:avLst/>
                </a:prstGeom>
                <a:solidFill>
                  <a:srgbClr val="000000">
                    <a:alpha val="5000"/>
                  </a:srgbClr>
                </a:solidFill>
                <a:ln w="9000">
                  <a:solidFill>
                    <a:srgbClr val="0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AutoForm 2"/>
              <p:cNvSpPr>
                <a:spLocks noChangeArrowheads="1"/>
              </p:cNvSpPr>
              <p:nvPr/>
            </p:nvSpPr>
            <p:spPr bwMode="auto">
              <a:xfrm rot="5400000">
                <a:off x="1909044" y="1924495"/>
                <a:ext cx="373380" cy="1839594"/>
              </a:xfrm>
              <a:prstGeom prst="roundRect">
                <a:avLst>
                  <a:gd name="adj" fmla="val 13032"/>
                </a:avLst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rgbClr val="00B0F0"/>
                </a:solidFill>
              </a:ln>
            </p:spPr>
            <p:txBody>
              <a:bodyPr rot="0" vert="horz" wrap="square" lIns="108000" tIns="108000" rIns="108000" bIns="108000" anchor="ctr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  <a:sym typeface="Wingdings" panose="05000000000000000000" pitchFamily="2" charset="2"/>
                  </a:rPr>
                  <a:t>  </a:t>
                </a:r>
                <a:r>
                  <a:rPr lang="en-US" b="1" kern="100" dirty="0">
                    <a:solidFill>
                      <a:srgbClr val="4472C4"/>
                    </a:solidFill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 In total: 49 + 6 questions</a:t>
                </a:r>
                <a:endParaRPr lang="de-DE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67246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ieren 20">
            <a:extLst>
              <a:ext uri="{FF2B5EF4-FFF2-40B4-BE49-F238E27FC236}">
                <a16:creationId xmlns:a16="http://schemas.microsoft.com/office/drawing/2014/main" id="{6896F68D-2559-10E5-42CC-9A1D9C8AB354}"/>
              </a:ext>
            </a:extLst>
          </p:cNvPr>
          <p:cNvGrpSpPr/>
          <p:nvPr/>
        </p:nvGrpSpPr>
        <p:grpSpPr>
          <a:xfrm>
            <a:off x="767287" y="355600"/>
            <a:ext cx="9824720" cy="5860553"/>
            <a:chOff x="767287" y="355600"/>
            <a:chExt cx="9824720" cy="5860553"/>
          </a:xfrm>
        </p:grpSpPr>
        <p:grpSp>
          <p:nvGrpSpPr>
            <p:cNvPr id="2" name="Gruppieren 1"/>
            <p:cNvGrpSpPr/>
            <p:nvPr/>
          </p:nvGrpSpPr>
          <p:grpSpPr>
            <a:xfrm>
              <a:off x="767287" y="355600"/>
              <a:ext cx="9824720" cy="5860553"/>
              <a:chOff x="-44756" y="0"/>
              <a:chExt cx="4093845" cy="3165581"/>
            </a:xfrm>
          </p:grpSpPr>
          <p:grpSp>
            <p:nvGrpSpPr>
              <p:cNvPr id="3" name="Gruppieren 2"/>
              <p:cNvGrpSpPr/>
              <p:nvPr/>
            </p:nvGrpSpPr>
            <p:grpSpPr>
              <a:xfrm>
                <a:off x="-10634" y="0"/>
                <a:ext cx="3967754" cy="2864790"/>
                <a:chOff x="-10634" y="0"/>
                <a:chExt cx="3968135" cy="2865064"/>
              </a:xfrm>
            </p:grpSpPr>
            <p:grpSp>
              <p:nvGrpSpPr>
                <p:cNvPr id="5" name="Gruppieren 4"/>
                <p:cNvGrpSpPr/>
                <p:nvPr/>
              </p:nvGrpSpPr>
              <p:grpSpPr>
                <a:xfrm>
                  <a:off x="-10634" y="0"/>
                  <a:ext cx="3968135" cy="2444113"/>
                  <a:chOff x="-10634" y="0"/>
                  <a:chExt cx="3968135" cy="2444113"/>
                </a:xfrm>
              </p:grpSpPr>
              <p:sp>
                <p:nvSpPr>
                  <p:cNvPr id="7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1916664" y="-518400"/>
                    <a:ext cx="374400" cy="1411200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US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55 questions</a:t>
                    </a:r>
                    <a:endParaRPr lang="de-DE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1227834" y="533600"/>
                    <a:ext cx="616555" cy="932496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Adjustments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kern="100" dirty="0"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15 questions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3236934" y="597135"/>
                    <a:ext cx="609919" cy="831215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Deletion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kern="100" dirty="0"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1 question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0" name="Gerader Verbinder 9"/>
                  <p:cNvCxnSpPr/>
                  <p:nvPr/>
                </p:nvCxnSpPr>
                <p:spPr>
                  <a:xfrm>
                    <a:off x="2891595" y="401266"/>
                    <a:ext cx="234677" cy="145218"/>
                  </a:xfrm>
                  <a:prstGeom prst="line">
                    <a:avLst/>
                  </a:prstGeom>
                  <a:solidFill>
                    <a:srgbClr val="000000">
                      <a:alpha val="5000"/>
                    </a:srgbClr>
                  </a:solidFill>
                  <a:ln w="9000">
                    <a:solidFill>
                      <a:srgbClr val="00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Gerader Verbinder 10"/>
                  <p:cNvCxnSpPr/>
                  <p:nvPr/>
                </p:nvCxnSpPr>
                <p:spPr>
                  <a:xfrm flipH="1">
                    <a:off x="1021860" y="410791"/>
                    <a:ext cx="303055" cy="177755"/>
                  </a:xfrm>
                  <a:prstGeom prst="line">
                    <a:avLst/>
                  </a:prstGeom>
                  <a:solidFill>
                    <a:srgbClr val="000000">
                      <a:alpha val="5000"/>
                    </a:srgbClr>
                  </a:solidFill>
                  <a:ln w="9000">
                    <a:solidFill>
                      <a:srgbClr val="00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161367" y="519549"/>
                    <a:ext cx="611188" cy="955190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Left idem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kern="100" dirty="0"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34 questions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2263064" y="550284"/>
                    <a:ext cx="594995" cy="909955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Split (1into2)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kern="100" dirty="0"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5x 1 question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4" name="Gerader Verbinder 13"/>
                  <p:cNvCxnSpPr/>
                  <p:nvPr/>
                </p:nvCxnSpPr>
                <p:spPr>
                  <a:xfrm rot="1577623">
                    <a:off x="2286234" y="460316"/>
                    <a:ext cx="200946" cy="109818"/>
                  </a:xfrm>
                  <a:prstGeom prst="line">
                    <a:avLst/>
                  </a:prstGeom>
                  <a:solidFill>
                    <a:srgbClr val="000000">
                      <a:alpha val="5000"/>
                    </a:srgbClr>
                  </a:solidFill>
                  <a:ln w="9000">
                    <a:solidFill>
                      <a:srgbClr val="00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Gerader Verbinder 14"/>
                  <p:cNvCxnSpPr/>
                  <p:nvPr/>
                </p:nvCxnSpPr>
                <p:spPr>
                  <a:xfrm rot="9386807" flipV="1">
                    <a:off x="1684395" y="461427"/>
                    <a:ext cx="176783" cy="129639"/>
                  </a:xfrm>
                  <a:prstGeom prst="line">
                    <a:avLst/>
                  </a:prstGeom>
                  <a:solidFill>
                    <a:srgbClr val="000000">
                      <a:alpha val="5000"/>
                    </a:srgbClr>
                  </a:solidFill>
                  <a:ln w="9000">
                    <a:solidFill>
                      <a:srgbClr val="00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" name="AutoForm 2"/>
                  <p:cNvSpPr>
                    <a:spLocks noChangeArrowheads="1"/>
                  </p:cNvSpPr>
                  <p:nvPr/>
                </p:nvSpPr>
                <p:spPr bwMode="auto">
                  <a:xfrm rot="5400000">
                    <a:off x="668873" y="944368"/>
                    <a:ext cx="746760" cy="1839595"/>
                  </a:xfrm>
                  <a:prstGeom prst="roundRect">
                    <a:avLst>
                      <a:gd name="adj" fmla="val 13032"/>
                    </a:avLst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</p:spPr>
                <p:txBody>
                  <a:bodyPr rot="0" vert="horz" wrap="square" lIns="108000" tIns="108000" rIns="108000" bIns="108000" anchor="ctr" anchorCtr="0" upright="1">
                    <a:noAutofit/>
                  </a:bodyPr>
                  <a:lstStyle/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b="1" kern="100" dirty="0">
                        <a:solidFill>
                          <a:srgbClr val="4472C4"/>
                        </a:solidFill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+ 9 questions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  <a:p>
                    <a:pPr algn="ctr">
                      <a:lnSpc>
                        <a:spcPct val="107000"/>
                      </a:lnSpc>
                    </a:pPr>
                    <a:r>
                      <a:rPr lang="en-US" sz="1600" kern="100" dirty="0">
                        <a:effectLst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via recommendations of the women suffering from GDM</a:t>
                    </a:r>
                    <a:endParaRPr lang="de-DE" sz="1600" kern="100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7" name="Gerader Verbinder 16"/>
                  <p:cNvCxnSpPr/>
                  <p:nvPr/>
                </p:nvCxnSpPr>
                <p:spPr>
                  <a:xfrm>
                    <a:off x="2038326" y="2237546"/>
                    <a:ext cx="1" cy="206567"/>
                  </a:xfrm>
                  <a:prstGeom prst="line">
                    <a:avLst/>
                  </a:prstGeom>
                  <a:solidFill>
                    <a:srgbClr val="000000">
                      <a:alpha val="5000"/>
                    </a:srgbClr>
                  </a:solidFill>
                  <a:ln w="9000">
                    <a:solidFill>
                      <a:srgbClr val="00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" name="AutoForm 2"/>
                <p:cNvSpPr>
                  <a:spLocks noChangeArrowheads="1"/>
                </p:cNvSpPr>
                <p:nvPr/>
              </p:nvSpPr>
              <p:spPr bwMode="auto">
                <a:xfrm rot="5400000">
                  <a:off x="1863202" y="1813186"/>
                  <a:ext cx="373380" cy="1730375"/>
                </a:xfrm>
                <a:prstGeom prst="roundRect">
                  <a:avLst>
                    <a:gd name="adj" fmla="val 13032"/>
                  </a:avLst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rgbClr val="00B0F0"/>
                  </a:solidFill>
                </a:ln>
              </p:spPr>
              <p:txBody>
                <a:bodyPr rot="0" vert="horz" wrap="square" lIns="108000" tIns="108000" rIns="108000" bIns="108000" anchor="ctr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</a:pP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  <a:sym typeface="Wingdings" panose="05000000000000000000" pitchFamily="2" charset="2"/>
                    </a:rPr>
                    <a:t>  </a:t>
                  </a:r>
                  <a:r>
                    <a:rPr lang="en-US" b="1" kern="100" dirty="0">
                      <a:solidFill>
                        <a:srgbClr val="4472C4"/>
                      </a:solidFill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 In total: 61 + 8 questions</a:t>
                  </a:r>
                  <a:endParaRPr lang="de-DE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" name="Textfeld 1"/>
              <p:cNvSpPr txBox="1"/>
              <p:nvPr/>
            </p:nvSpPr>
            <p:spPr>
              <a:xfrm>
                <a:off x="-44756" y="2982827"/>
                <a:ext cx="4093845" cy="182754"/>
              </a:xfrm>
              <a:prstGeom prst="rect">
                <a:avLst/>
              </a:prstGeom>
              <a:solidFill>
                <a:prstClr val="white"/>
              </a:solidFill>
              <a:ln>
                <a:noFill/>
              </a:ln>
            </p:spPr>
            <p:txBody>
              <a:bodyPr rot="0" spcFirstLastPara="0" vert="horz" wrap="square" lIns="108000" tIns="108000" rIns="108000" bIns="108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1000"/>
                  </a:spcAft>
                </a:pPr>
                <a:r>
                  <a:rPr lang="en-US" sz="1200" b="1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Figure 5.</a:t>
                </a:r>
                <a:r>
                  <a:rPr lang="en-US" sz="12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 Flow </a:t>
                </a:r>
                <a:r>
                  <a:rPr lang="en-US" sz="1200" kern="100" dirty="0">
                    <a:ea typeface="Calibri" panose="020F0502020204030204" pitchFamily="34" charset="0"/>
                    <a:cs typeface="Times New Roman" panose="02020603050405020304" pitchFamily="18" charset="0"/>
                  </a:rPr>
                  <a:t>c</a:t>
                </a:r>
                <a:r>
                  <a:rPr lang="en-US" sz="1200" kern="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hart of the independent peer-consolidation process</a:t>
                </a:r>
                <a:endParaRPr lang="de-DE" sz="12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" name="AutoForm 2"/>
            <p:cNvSpPr>
              <a:spLocks noChangeArrowheads="1"/>
            </p:cNvSpPr>
            <p:nvPr/>
          </p:nvSpPr>
          <p:spPr bwMode="auto">
            <a:xfrm rot="5400000">
              <a:off x="7178665" y="1966634"/>
              <a:ext cx="1382372" cy="3679664"/>
            </a:xfrm>
            <a:prstGeom prst="roundRect">
              <a:avLst>
                <a:gd name="adj" fmla="val 13032"/>
              </a:avLst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rot="0" vert="horz" wrap="square" lIns="91440" tIns="45720" rIns="91440" bIns="45720" anchor="ctr" anchorCtr="0" upright="1">
              <a:noAutofit/>
            </a:bodyPr>
            <a:lstStyle/>
            <a:p>
              <a:pPr algn="ctr">
                <a:lnSpc>
                  <a:spcPct val="107000"/>
                </a:lnSpc>
              </a:pPr>
              <a:r>
                <a:rPr lang="en-US" sz="1600" b="1" kern="100" dirty="0">
                  <a:solidFill>
                    <a:srgbClr val="4472C4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+ 2 questions</a:t>
              </a:r>
              <a:endParaRPr lang="de-DE" sz="16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107000"/>
                </a:lnSpc>
              </a:pPr>
              <a:r>
                <a:rPr lang="en-US" sz="1600" kern="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via recommendation of an expert</a:t>
              </a:r>
              <a:endParaRPr lang="de-DE" sz="16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" name="Gerader Verbinder 18"/>
          <p:cNvCxnSpPr/>
          <p:nvPr/>
        </p:nvCxnSpPr>
        <p:spPr>
          <a:xfrm rot="9386807" flipV="1">
            <a:off x="4359545" y="2842307"/>
            <a:ext cx="182880" cy="130175"/>
          </a:xfrm>
          <a:prstGeom prst="line">
            <a:avLst/>
          </a:prstGeom>
          <a:solidFill>
            <a:srgbClr val="000000">
              <a:alpha val="5000"/>
            </a:srgbClr>
          </a:solidFill>
          <a:ln w="9000">
            <a:solidFill>
              <a:srgbClr val="0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/>
          <p:cNvCxnSpPr/>
          <p:nvPr/>
        </p:nvCxnSpPr>
        <p:spPr>
          <a:xfrm rot="1577623">
            <a:off x="7134542" y="2885405"/>
            <a:ext cx="208915" cy="111125"/>
          </a:xfrm>
          <a:prstGeom prst="line">
            <a:avLst/>
          </a:prstGeom>
          <a:solidFill>
            <a:srgbClr val="000000">
              <a:alpha val="5000"/>
            </a:srgbClr>
          </a:solidFill>
          <a:ln w="9000">
            <a:solidFill>
              <a:srgbClr val="0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29100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1</Words>
  <Application>Microsoft Office PowerPoint</Application>
  <PresentationFormat>Breitbild</PresentationFormat>
  <Paragraphs>9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URWPalladioL-Roma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linikum Südstadt Rostoc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rof. Dr. J. Stubert</dc:creator>
  <cp:lastModifiedBy>Lisa Güldner</cp:lastModifiedBy>
  <cp:revision>17</cp:revision>
  <dcterms:created xsi:type="dcterms:W3CDTF">2025-01-21T09:34:20Z</dcterms:created>
  <dcterms:modified xsi:type="dcterms:W3CDTF">2026-01-30T14:41:46Z</dcterms:modified>
</cp:coreProperties>
</file>